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png" ContentType="image/png"/>
  <Override PartName="/ppt/media/image5.jpeg" ContentType="image/jpe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EB64E-9CF9-4804-A3D5-1587F705A2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54A6C-CF95-4CBD-A3CA-255A3B7B1B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9C1A2-5AA7-48A4-BEAB-56C9780868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1298DF-6E70-494A-B568-6761879B60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E221B-B7CB-4054-933F-C6DC1DFF1A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DA20A-833A-4669-A780-7D4E574598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CED79-BFCE-406B-BA63-2DE3D3AB47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50F36-330C-4E7A-B378-E59A337C07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7C63E-314A-4412-80F8-47B94F629C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6EC84-7D51-44CB-BF93-D35749F87C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806814-23E7-4309-B1AF-D839D26F29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70D235-C09A-478A-BBBF-09220029D6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357330-7E15-41AD-BB8A-1191C92E8F1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C:\TuruKameData\大学\受信添付\111031_09\長紫.jpg"/>
          <p:cNvPicPr/>
          <p:nvPr/>
        </p:nvPicPr>
        <p:blipFill>
          <a:blip r:embed="rId1"/>
          <a:srcRect l="0" t="3769" r="2754" b="4620"/>
          <a:stretch/>
        </p:blipFill>
        <p:spPr>
          <a:xfrm>
            <a:off x="5973840" y="3800520"/>
            <a:ext cx="2630520" cy="2905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C:\TuruKameData\大学\受信添付\111031_08\senryotype.jpg"/>
          <p:cNvPicPr/>
          <p:nvPr/>
        </p:nvPicPr>
        <p:blipFill>
          <a:blip r:embed="rId2"/>
          <a:stretch/>
        </p:blipFill>
        <p:spPr>
          <a:xfrm>
            <a:off x="5940360" y="1193760"/>
            <a:ext cx="2630520" cy="2252880"/>
          </a:xfrm>
          <a:prstGeom prst="rect">
            <a:avLst/>
          </a:prstGeom>
          <a:ln w="0">
            <a:noFill/>
          </a:ln>
        </p:spPr>
      </p:pic>
      <p:sp>
        <p:nvSpPr>
          <p:cNvPr id="43" name="テキスト ボックス 3"/>
          <p:cNvSpPr/>
          <p:nvPr/>
        </p:nvSpPr>
        <p:spPr>
          <a:xfrm>
            <a:off x="-7200" y="260280"/>
            <a:ext cx="423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. Photographs of the vegetables used in this stud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5" descr="C:\TuruKameData\大学\受信添付\111031_08\delica.png"/>
          <p:cNvPicPr/>
          <p:nvPr/>
        </p:nvPicPr>
        <p:blipFill>
          <a:blip r:embed="rId3"/>
          <a:srcRect l="2761" t="0" r="8893" b="0"/>
          <a:stretch/>
        </p:blipFill>
        <p:spPr>
          <a:xfrm>
            <a:off x="468360" y="1166760"/>
            <a:ext cx="2265480" cy="20350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C:\TuruKameData\大学\受信添付\111031_08\kampari.png"/>
          <p:cNvPicPr/>
          <p:nvPr/>
        </p:nvPicPr>
        <p:blipFill>
          <a:blip r:embed="rId4"/>
          <a:stretch/>
        </p:blipFill>
        <p:spPr>
          <a:xfrm>
            <a:off x="2860560" y="1166760"/>
            <a:ext cx="2265480" cy="20480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7" descr="C:\TuruKameData\大学\受信添付\111031_08\kurimasaru.JPG"/>
          <p:cNvPicPr/>
          <p:nvPr/>
        </p:nvPicPr>
        <p:blipFill>
          <a:blip r:embed="rId5"/>
          <a:srcRect l="6101" t="0" r="0" b="0"/>
          <a:stretch/>
        </p:blipFill>
        <p:spPr>
          <a:xfrm>
            <a:off x="2871720" y="3781440"/>
            <a:ext cx="2354400" cy="18795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8" descr="C:\TuruKameData\大学\受信添付\111031_08\ebisu.JPG"/>
          <p:cNvPicPr/>
          <p:nvPr/>
        </p:nvPicPr>
        <p:blipFill>
          <a:blip r:embed="rId6"/>
          <a:srcRect l="10307" t="0" r="0" b="5401"/>
          <a:stretch/>
        </p:blipFill>
        <p:spPr>
          <a:xfrm>
            <a:off x="352440" y="3781440"/>
            <a:ext cx="2376360" cy="1879560"/>
          </a:xfrm>
          <a:prstGeom prst="rect">
            <a:avLst/>
          </a:prstGeom>
          <a:ln w="0">
            <a:noFill/>
          </a:ln>
        </p:spPr>
      </p:pic>
      <p:sp>
        <p:nvSpPr>
          <p:cNvPr id="48" name="テキスト ボックス 2"/>
          <p:cNvSpPr/>
          <p:nvPr/>
        </p:nvSpPr>
        <p:spPr>
          <a:xfrm>
            <a:off x="619560" y="876240"/>
            <a:ext cx="1995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elica (regular) tomat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11"/>
          <p:cNvSpPr/>
          <p:nvPr/>
        </p:nvSpPr>
        <p:spPr>
          <a:xfrm>
            <a:off x="3281040" y="855720"/>
            <a:ext cx="1448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ampari tomat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12"/>
          <p:cNvSpPr/>
          <p:nvPr/>
        </p:nvSpPr>
        <p:spPr>
          <a:xfrm>
            <a:off x="912600" y="3492360"/>
            <a:ext cx="135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bisu pumpk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13"/>
          <p:cNvSpPr/>
          <p:nvPr/>
        </p:nvSpPr>
        <p:spPr>
          <a:xfrm>
            <a:off x="3208320" y="3471840"/>
            <a:ext cx="1815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Kurimasaru pumpk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14"/>
          <p:cNvSpPr/>
          <p:nvPr/>
        </p:nvSpPr>
        <p:spPr>
          <a:xfrm>
            <a:off x="6519240" y="879480"/>
            <a:ext cx="1480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enryo eggplan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15"/>
          <p:cNvSpPr/>
          <p:nvPr/>
        </p:nvSpPr>
        <p:spPr>
          <a:xfrm>
            <a:off x="6545160" y="3500280"/>
            <a:ext cx="146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hoshi eggplan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2T03:49:10Z</dcterms:created>
  <dc:creator>Y. Shimada</dc:creator>
  <dc:description/>
  <dc:language>en-US</dc:language>
  <cp:lastModifiedBy>Y. Shimada</cp:lastModifiedBy>
  <dcterms:modified xsi:type="dcterms:W3CDTF">2011-12-02T03:15:00Z</dcterms:modified>
  <cp:revision>8</cp:revision>
  <dc:subject/>
  <dc:title>PowerPoint プレゼンテーション</dc:title>
</cp:coreProperties>
</file>